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6858000" cy="9144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771" autoAdjust="0"/>
    <p:restoredTop sz="94660"/>
  </p:normalViewPr>
  <p:slideViewPr>
    <p:cSldViewPr snapToGrid="0">
      <p:cViewPr varScale="1">
        <p:scale>
          <a:sx n="86" d="100"/>
          <a:sy n="86" d="100"/>
        </p:scale>
        <p:origin x="280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768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0231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4543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6801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283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1039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1410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812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498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0607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2266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9436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/>
          <p:cNvSpPr/>
          <p:nvPr/>
        </p:nvSpPr>
        <p:spPr>
          <a:xfrm>
            <a:off x="492684" y="-100367"/>
            <a:ext cx="6113930" cy="28328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b="1" dirty="0" smtClean="0">
                <a:solidFill>
                  <a:schemeClr val="tx1"/>
                </a:solidFill>
              </a:rPr>
              <a:t>Figure </a:t>
            </a:r>
            <a:r>
              <a:rPr lang="en-US" altLang="ja-JP" b="1" dirty="0">
                <a:solidFill>
                  <a:schemeClr val="tx1"/>
                </a:solidFill>
              </a:rPr>
              <a:t>7. </a:t>
            </a:r>
            <a:r>
              <a:rPr lang="en-US" altLang="ja-JP" dirty="0">
                <a:solidFill>
                  <a:schemeClr val="tx1"/>
                </a:solidFill>
              </a:rPr>
              <a:t>Effect of cardiac GPR14 expression on DS37001789 and plasma concentrations of DS37001789 after 4 weeks of administration in pressure-overload mice. </a:t>
            </a:r>
            <a:endParaRPr lang="ja-JP" altLang="ja-JP" dirty="0">
              <a:solidFill>
                <a:schemeClr val="tx1"/>
              </a:solidFill>
            </a:endParaRPr>
          </a:p>
          <a:p>
            <a:r>
              <a:rPr lang="en-US" altLang="ja-JP" dirty="0">
                <a:solidFill>
                  <a:schemeClr val="tx1"/>
                </a:solidFill>
              </a:rPr>
              <a:t>(B) GPR14 expression in rat isolated cardiomyocyte by western blot analysis. GPR14 expression levels normalized to GAPDH levels.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3591" y="2531328"/>
            <a:ext cx="4724431" cy="2395253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3591" y="5588450"/>
            <a:ext cx="4724431" cy="24955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2744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.pptx" id="{1E39CEC3-E423-4FB3-BDE8-ECFA3A5FB86C}" vid="{AA5D0353-88DC-447E-A034-4D9D51FBF585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5301</TotalTime>
  <Words>46</Words>
  <Application>Microsoft Office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DAIICHI SANKYO CO.,LTD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ISHI MINA / 西 美奈</dc:creator>
  <cp:lastModifiedBy>NISHI MINA / 西 美奈</cp:lastModifiedBy>
  <cp:revision>102</cp:revision>
  <cp:lastPrinted>2019-04-26T09:07:51Z</cp:lastPrinted>
  <dcterms:created xsi:type="dcterms:W3CDTF">2018-05-08T23:00:01Z</dcterms:created>
  <dcterms:modified xsi:type="dcterms:W3CDTF">2020-01-26T23:31:44Z</dcterms:modified>
</cp:coreProperties>
</file>